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4"/>
  </p:sldMasterIdLst>
  <p:notesMasterIdLst>
    <p:notesMasterId r:id="rId17"/>
  </p:notesMasterIdLst>
  <p:sldIdLst>
    <p:sldId id="278" r:id="rId5"/>
    <p:sldId id="285" r:id="rId6"/>
    <p:sldId id="291" r:id="rId7"/>
    <p:sldId id="296" r:id="rId8"/>
    <p:sldId id="280" r:id="rId9"/>
    <p:sldId id="299" r:id="rId10"/>
    <p:sldId id="297" r:id="rId11"/>
    <p:sldId id="295" r:id="rId12"/>
    <p:sldId id="286" r:id="rId13"/>
    <p:sldId id="292" r:id="rId14"/>
    <p:sldId id="290" r:id="rId15"/>
    <p:sldId id="293" r:id="rId16"/>
  </p:sldIdLst>
  <p:sldSz cx="6858000" cy="107632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9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nric Domingo" initials="ED" lastIdx="1" clrIdx="0">
    <p:extLst>
      <p:ext uri="{19B8F6BF-5375-455C-9EA6-DF929625EA0E}">
        <p15:presenceInfo xmlns:p15="http://schemas.microsoft.com/office/powerpoint/2012/main" userId="S::whgu0379@ox.ac.uk::21e57f0f-e6bf-4167-bd4d-423a8b52049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67" autoAdjust="0"/>
    <p:restoredTop sz="95268" autoAdjust="0"/>
  </p:normalViewPr>
  <p:slideViewPr>
    <p:cSldViewPr snapToGrid="0">
      <p:cViewPr varScale="1">
        <p:scale>
          <a:sx n="43" d="100"/>
          <a:sy n="43" d="100"/>
        </p:scale>
        <p:origin x="2244" y="72"/>
      </p:cViewPr>
      <p:guideLst>
        <p:guide orient="horz" pos="339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7A4D07-49B7-4139-8D4C-5BE60ACA113B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6338" y="1143000"/>
            <a:ext cx="19653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B7A044-7703-48A6-88E5-8FE87465D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240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B7A044-7703-48A6-88E5-8FE87465DAE4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3034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61486"/>
            <a:ext cx="5829300" cy="37472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653199"/>
            <a:ext cx="5143500" cy="259862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1581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809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73043"/>
            <a:ext cx="1478756" cy="912135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73043"/>
            <a:ext cx="4350544" cy="912135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600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437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683341"/>
            <a:ext cx="5915025" cy="447721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202910"/>
            <a:ext cx="5915025" cy="235446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5648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865217"/>
            <a:ext cx="2914650" cy="6829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865217"/>
            <a:ext cx="2914650" cy="6829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337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3046"/>
            <a:ext cx="5915025" cy="208039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638492"/>
            <a:ext cx="2901255" cy="129308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931576"/>
            <a:ext cx="2901255" cy="578275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638492"/>
            <a:ext cx="2915543" cy="129308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931576"/>
            <a:ext cx="2915543" cy="578275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357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150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2937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17550"/>
            <a:ext cx="2211884" cy="251142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49711"/>
            <a:ext cx="3471863" cy="764888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28975"/>
            <a:ext cx="2211884" cy="598207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9271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17550"/>
            <a:ext cx="2211884" cy="251142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49711"/>
            <a:ext cx="3471863" cy="764888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28975"/>
            <a:ext cx="2211884" cy="598207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0244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73046"/>
            <a:ext cx="5915025" cy="208039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865217"/>
            <a:ext cx="5915025" cy="68291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975941"/>
            <a:ext cx="1543050" cy="5730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EEC6A-7896-44F7-A28F-893A9B0C6553}" type="datetimeFigureOut">
              <a:rPr lang="en-GB" smtClean="0"/>
              <a:t>0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975941"/>
            <a:ext cx="2314575" cy="5730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975941"/>
            <a:ext cx="1543050" cy="5730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1FF13-DB3F-453A-A50B-6098B2A61B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0727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1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tiff"/><Relationship Id="rId4" Type="http://schemas.openxmlformats.org/officeDocument/2006/relationships/image" Target="../media/image17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5">
            <a:extLst>
              <a:ext uri="{FF2B5EF4-FFF2-40B4-BE49-F238E27FC236}">
                <a16:creationId xmlns:a16="http://schemas.microsoft.com/office/drawing/2014/main" id="{BB31C5B0-EFB4-AB47-9991-BEEA0E9CFDA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263" y="7928602"/>
            <a:ext cx="4075329" cy="2513845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20598"/>
            <a:ext cx="5915025" cy="775270"/>
          </a:xfrm>
        </p:spPr>
        <p:txBody>
          <a:bodyPr>
            <a:normAutofit/>
          </a:bodyPr>
          <a:lstStyle/>
          <a:p>
            <a:pPr algn="just"/>
            <a:r>
              <a:rPr lang="en-GB" sz="1400" dirty="0"/>
              <a:t>Supplementary Figure 1. </a:t>
            </a:r>
            <a:endParaRPr lang="en-GB" sz="1400" b="1" dirty="0"/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5EE6A3-7E5F-0F4B-B0D4-97BE469555BD}"/>
              </a:ext>
            </a:extLst>
          </p:cNvPr>
          <p:cNvSpPr txBox="1"/>
          <p:nvPr/>
        </p:nvSpPr>
        <p:spPr>
          <a:xfrm>
            <a:off x="957961" y="712172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C67E73-2313-2943-8394-A3D659FEBEB6}"/>
              </a:ext>
            </a:extLst>
          </p:cNvPr>
          <p:cNvSpPr txBox="1"/>
          <p:nvPr/>
        </p:nvSpPr>
        <p:spPr>
          <a:xfrm>
            <a:off x="1042965" y="4028735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CFF5B74-BA52-5B47-9170-959BB4410089}"/>
              </a:ext>
            </a:extLst>
          </p:cNvPr>
          <p:cNvSpPr txBox="1"/>
          <p:nvPr/>
        </p:nvSpPr>
        <p:spPr>
          <a:xfrm>
            <a:off x="1145582" y="7875990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1CB8ECA-2AA9-DC4B-A2CD-678FCF8E329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4843" y="779574"/>
            <a:ext cx="3716925" cy="302433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8992488A-E2F8-F842-B386-E96221670BF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2456" y="4041647"/>
            <a:ext cx="3694176" cy="3666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48009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D0DF96C-3866-0843-87C0-09EE19B7D6F9}"/>
              </a:ext>
            </a:extLst>
          </p:cNvPr>
          <p:cNvGrpSpPr/>
          <p:nvPr/>
        </p:nvGrpSpPr>
        <p:grpSpPr>
          <a:xfrm>
            <a:off x="1603948" y="906905"/>
            <a:ext cx="3275351" cy="3267856"/>
            <a:chOff x="0" y="713983"/>
            <a:chExt cx="5630449" cy="563044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FED40B4-58A8-FA4E-93FC-AA07A0A1D9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713983"/>
              <a:ext cx="5630449" cy="5630449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D042EE0-327E-7540-BEE5-917EC08A87F7}"/>
                </a:ext>
              </a:extLst>
            </p:cNvPr>
            <p:cNvSpPr/>
            <p:nvPr/>
          </p:nvSpPr>
          <p:spPr>
            <a:xfrm>
              <a:off x="3169085" y="1027134"/>
              <a:ext cx="977030" cy="1240077"/>
            </a:xfrm>
            <a:prstGeom prst="rect">
              <a:avLst/>
            </a:prstGeom>
            <a:noFill/>
            <a:ln w="3810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54A65E9B-6C4D-C44B-8F10-03629FF2BEA6}"/>
                </a:ext>
              </a:extLst>
            </p:cNvPr>
            <p:cNvSpPr/>
            <p:nvPr/>
          </p:nvSpPr>
          <p:spPr>
            <a:xfrm>
              <a:off x="2131513" y="2079320"/>
              <a:ext cx="1039660" cy="551145"/>
            </a:xfrm>
            <a:prstGeom prst="rect">
              <a:avLst/>
            </a:prstGeom>
            <a:noFill/>
            <a:ln w="3810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10A503D9-AD4B-004E-BB8F-7BE4027138D8}"/>
                </a:ext>
              </a:extLst>
            </p:cNvPr>
            <p:cNvSpPr/>
            <p:nvPr/>
          </p:nvSpPr>
          <p:spPr>
            <a:xfrm>
              <a:off x="1077238" y="2642992"/>
              <a:ext cx="1052187" cy="1002083"/>
            </a:xfrm>
            <a:prstGeom prst="rect">
              <a:avLst/>
            </a:prstGeom>
            <a:noFill/>
            <a:ln w="3810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12181D6D-7F70-3F4C-BB03-8DF46FADCE2E}"/>
                </a:ext>
              </a:extLst>
            </p:cNvPr>
            <p:cNvSpPr/>
            <p:nvPr/>
          </p:nvSpPr>
          <p:spPr>
            <a:xfrm>
              <a:off x="87682" y="3657600"/>
              <a:ext cx="977030" cy="225468"/>
            </a:xfrm>
            <a:prstGeom prst="rect">
              <a:avLst/>
            </a:prstGeom>
            <a:noFill/>
            <a:ln w="3810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8" name="Title 1">
            <a:extLst>
              <a:ext uri="{FF2B5EF4-FFF2-40B4-BE49-F238E27FC236}">
                <a16:creationId xmlns:a16="http://schemas.microsoft.com/office/drawing/2014/main" id="{F1724401-CD56-4D42-8658-B3CE254130F9}"/>
              </a:ext>
            </a:extLst>
          </p:cNvPr>
          <p:cNvSpPr txBox="1">
            <a:spLocks/>
          </p:cNvSpPr>
          <p:nvPr/>
        </p:nvSpPr>
        <p:spPr>
          <a:xfrm>
            <a:off x="178961" y="125836"/>
            <a:ext cx="6679039" cy="746619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 dirty="0"/>
              <a:t>Supplementary Figure 10</a:t>
            </a:r>
          </a:p>
        </p:txBody>
      </p:sp>
    </p:spTree>
    <p:extLst>
      <p:ext uri="{BB962C8B-B14F-4D97-AF65-F5344CB8AC3E}">
        <p14:creationId xmlns:p14="http://schemas.microsoft.com/office/powerpoint/2010/main" val="13870880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5B2A107-08C8-4B41-A4C7-B116A8C0B0E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50"/>
          <a:stretch/>
        </p:blipFill>
        <p:spPr>
          <a:xfrm>
            <a:off x="1" y="1173124"/>
            <a:ext cx="6857999" cy="50314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00655908-3222-104C-8597-282E178B6F3A}"/>
              </a:ext>
            </a:extLst>
          </p:cNvPr>
          <p:cNvSpPr txBox="1">
            <a:spLocks/>
          </p:cNvSpPr>
          <p:nvPr/>
        </p:nvSpPr>
        <p:spPr>
          <a:xfrm>
            <a:off x="178961" y="125836"/>
            <a:ext cx="6679039" cy="746619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 dirty="0"/>
              <a:t>Supplementary Figure 11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957057C-196F-D041-8F1F-D0C240E60D2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78" y="6563308"/>
            <a:ext cx="6289524" cy="335441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593E488-5F89-8845-AACC-B8D2F9C42CB9}"/>
              </a:ext>
            </a:extLst>
          </p:cNvPr>
          <p:cNvSpPr txBox="1"/>
          <p:nvPr/>
        </p:nvSpPr>
        <p:spPr>
          <a:xfrm>
            <a:off x="144088" y="835379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676966-5900-C249-9933-22970299EC74}"/>
              </a:ext>
            </a:extLst>
          </p:cNvPr>
          <p:cNvSpPr txBox="1"/>
          <p:nvPr/>
        </p:nvSpPr>
        <p:spPr>
          <a:xfrm>
            <a:off x="174233" y="6301681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866456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B44F58-CD31-5242-925C-E6AD3508E7F3}"/>
              </a:ext>
            </a:extLst>
          </p:cNvPr>
          <p:cNvSpPr txBox="1">
            <a:spLocks/>
          </p:cNvSpPr>
          <p:nvPr/>
        </p:nvSpPr>
        <p:spPr>
          <a:xfrm>
            <a:off x="178961" y="125836"/>
            <a:ext cx="6679039" cy="746619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/>
              <a:t>Supplementary </a:t>
            </a:r>
            <a:r>
              <a:rPr lang="en-GB" sz="1400" dirty="0"/>
              <a:t>Figure 12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FB22F56-9FC1-4688-9280-23912B1FBF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611" y="949915"/>
            <a:ext cx="5423648" cy="31221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5A25ED2-ACF9-41D1-BFEE-F5948C35DB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611" y="4180874"/>
            <a:ext cx="5320145" cy="296257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50ADF7E-18CA-45D7-A3A7-6467A26E67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611" y="7143453"/>
            <a:ext cx="5839369" cy="2838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468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D7E04A9-FDBC-AB44-84F9-221D1529C3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4851" y="1011545"/>
            <a:ext cx="3233583" cy="565350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D3463FE-B92A-5349-88F1-E6C398DBED1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225"/>
          <a:stretch/>
        </p:blipFill>
        <p:spPr>
          <a:xfrm>
            <a:off x="964828" y="6759058"/>
            <a:ext cx="4731297" cy="385319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1EFB0FF-949F-CC48-8599-AD64EBF5D653}"/>
              </a:ext>
            </a:extLst>
          </p:cNvPr>
          <p:cNvSpPr txBox="1"/>
          <p:nvPr/>
        </p:nvSpPr>
        <p:spPr>
          <a:xfrm>
            <a:off x="561765" y="6717108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16B2D8B-69A0-EB48-AD3D-3D08490E6FD2}"/>
              </a:ext>
            </a:extLst>
          </p:cNvPr>
          <p:cNvSpPr txBox="1"/>
          <p:nvPr/>
        </p:nvSpPr>
        <p:spPr>
          <a:xfrm>
            <a:off x="1023159" y="995816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D7DC242D-E0DC-0D4E-8828-D776AD546513}"/>
              </a:ext>
            </a:extLst>
          </p:cNvPr>
          <p:cNvSpPr txBox="1">
            <a:spLocks/>
          </p:cNvSpPr>
          <p:nvPr/>
        </p:nvSpPr>
        <p:spPr>
          <a:xfrm>
            <a:off x="471488" y="20599"/>
            <a:ext cx="5915025" cy="36933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GB" sz="1400" dirty="0"/>
              <a:t>Supplementary Figure 2. 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4134602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4A7A1121-E771-5545-A4FC-731AE6A0FD87}"/>
              </a:ext>
            </a:extLst>
          </p:cNvPr>
          <p:cNvSpPr txBox="1">
            <a:spLocks/>
          </p:cNvSpPr>
          <p:nvPr/>
        </p:nvSpPr>
        <p:spPr>
          <a:xfrm>
            <a:off x="89480" y="70226"/>
            <a:ext cx="6679039" cy="434967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 dirty="0"/>
              <a:t>Supplementary Figure 3.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53FA3E-6BBF-9C4C-A061-D23A42C29DDE}"/>
              </a:ext>
            </a:extLst>
          </p:cNvPr>
          <p:cNvSpPr txBox="1"/>
          <p:nvPr/>
        </p:nvSpPr>
        <p:spPr>
          <a:xfrm>
            <a:off x="3352575" y="4095188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1AE16DC-280F-4B4F-97BD-E4217B8C9B8C}"/>
              </a:ext>
            </a:extLst>
          </p:cNvPr>
          <p:cNvSpPr txBox="1"/>
          <p:nvPr/>
        </p:nvSpPr>
        <p:spPr>
          <a:xfrm>
            <a:off x="252682" y="4125906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0638526-20E9-4881-A6AA-CF47C198AAB0}"/>
              </a:ext>
            </a:extLst>
          </p:cNvPr>
          <p:cNvSpPr txBox="1"/>
          <p:nvPr/>
        </p:nvSpPr>
        <p:spPr>
          <a:xfrm>
            <a:off x="277284" y="6635065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125C79E-502F-A148-B246-C99B62B888F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424" y="4218876"/>
            <a:ext cx="2776220" cy="20447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695CC80C-5A4A-B444-9358-C998F56418DF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9580" y="4182005"/>
            <a:ext cx="2776220" cy="2044700"/>
          </a:xfrm>
          <a:prstGeom prst="rect">
            <a:avLst/>
          </a:prstGeom>
        </p:spPr>
      </p:pic>
      <p:pic>
        <p:nvPicPr>
          <p:cNvPr id="19" name="Picture 18" descr="Chart, scatter chart&#10;&#10;Description automatically generated">
            <a:extLst>
              <a:ext uri="{FF2B5EF4-FFF2-40B4-BE49-F238E27FC236}">
                <a16:creationId xmlns:a16="http://schemas.microsoft.com/office/drawing/2014/main" id="{C97B234C-40AD-A144-BC52-D180048F4A6C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597" y="6940955"/>
            <a:ext cx="2500022" cy="1985592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B50C708-F704-CF48-9F75-3DED26D58805}"/>
              </a:ext>
            </a:extLst>
          </p:cNvPr>
          <p:cNvSpPr txBox="1"/>
          <p:nvPr/>
        </p:nvSpPr>
        <p:spPr>
          <a:xfrm>
            <a:off x="3261374" y="6647355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B889ECB-C857-409C-1573-A9918788613B}"/>
              </a:ext>
            </a:extLst>
          </p:cNvPr>
          <p:cNvSpPr txBox="1"/>
          <p:nvPr/>
        </p:nvSpPr>
        <p:spPr>
          <a:xfrm>
            <a:off x="3349332" y="1509245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3C919B2-3344-D358-3C64-1B0A32624E68}"/>
              </a:ext>
            </a:extLst>
          </p:cNvPr>
          <p:cNvSpPr txBox="1"/>
          <p:nvPr/>
        </p:nvSpPr>
        <p:spPr>
          <a:xfrm>
            <a:off x="249439" y="1559627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AFB673B8-ECF1-FBAF-DA35-121E6FCD0FC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972" y="1594500"/>
            <a:ext cx="2764402" cy="20447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81FA302-DB5E-FA37-ACC7-09EAB9BC0B7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2610" y="1594501"/>
            <a:ext cx="2863190" cy="204469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FB239F2-C6CF-BD7E-5D01-16818CC66407}"/>
              </a:ext>
            </a:extLst>
          </p:cNvPr>
          <p:cNvPicPr/>
          <p:nvPr/>
        </p:nvPicPr>
        <p:blipFill>
          <a:blip r:embed="rId7"/>
          <a:stretch/>
        </p:blipFill>
        <p:spPr>
          <a:xfrm>
            <a:off x="3729580" y="6742148"/>
            <a:ext cx="2892923" cy="2193266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1866080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0729C0-CB7D-41EE-98B1-DC9F1E5B3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73047"/>
            <a:ext cx="5915025" cy="806132"/>
          </a:xfrm>
        </p:spPr>
        <p:txBody>
          <a:bodyPr>
            <a:normAutofit/>
          </a:bodyPr>
          <a:lstStyle/>
          <a:p>
            <a:r>
              <a:rPr lang="en-GB" sz="1400" dirty="0"/>
              <a:t>Supplementary Figure 4.  </a:t>
            </a:r>
            <a:br>
              <a:rPr lang="en-GB" sz="2800" dirty="0"/>
            </a:br>
            <a:endParaRPr lang="en-GB" sz="28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D063C5F-EF46-4396-B062-951F93C01F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4732" y="1856606"/>
            <a:ext cx="4328535" cy="5182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40202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8961" y="192948"/>
            <a:ext cx="6679039" cy="453005"/>
          </a:xfrm>
        </p:spPr>
        <p:txBody>
          <a:bodyPr>
            <a:noAutofit/>
          </a:bodyPr>
          <a:lstStyle/>
          <a:p>
            <a:pPr fontAlgn="base"/>
            <a:r>
              <a:rPr lang="en-GB" sz="1400" dirty="0"/>
              <a:t>Supplementary </a:t>
            </a:r>
            <a:r>
              <a:rPr lang="en-GB" sz="1400"/>
              <a:t>Figure 5. </a:t>
            </a:r>
            <a:endParaRPr lang="en-GB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AEE3657-B49A-514C-A900-196A1A32C2F4}"/>
              </a:ext>
            </a:extLst>
          </p:cNvPr>
          <p:cNvSpPr txBox="1"/>
          <p:nvPr/>
        </p:nvSpPr>
        <p:spPr>
          <a:xfrm>
            <a:off x="401484" y="819047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1C1DBC9-2B06-6B41-8B31-7A058270D5CA}"/>
              </a:ext>
            </a:extLst>
          </p:cNvPr>
          <p:cNvSpPr txBox="1"/>
          <p:nvPr/>
        </p:nvSpPr>
        <p:spPr>
          <a:xfrm>
            <a:off x="339067" y="6738429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8B35F7B-72EC-A948-A7F8-DF38F5B1C6B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479" y="6943346"/>
            <a:ext cx="5713743" cy="244874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517F6A1-3C3A-564A-8EB6-6DDEF8A3A10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7225" y="820556"/>
            <a:ext cx="5693658" cy="5693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5887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4A7A1121-E771-5545-A4FC-731AE6A0FD87}"/>
              </a:ext>
            </a:extLst>
          </p:cNvPr>
          <p:cNvSpPr txBox="1">
            <a:spLocks/>
          </p:cNvSpPr>
          <p:nvPr/>
        </p:nvSpPr>
        <p:spPr>
          <a:xfrm>
            <a:off x="89480" y="70226"/>
            <a:ext cx="6679039" cy="761047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 dirty="0"/>
              <a:t>Supplementary Figure 6. 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3008A5AA-6F5C-354A-B465-16195C63F035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466" y="1236690"/>
            <a:ext cx="2811855" cy="2163735"/>
          </a:xfrm>
          <a:prstGeom prst="rect">
            <a:avLst/>
          </a:prstGeom>
        </p:spPr>
      </p:pic>
      <p:pic>
        <p:nvPicPr>
          <p:cNvPr id="22" name="Picture 21" descr="Text&#10;&#10;Description automatically generated">
            <a:extLst>
              <a:ext uri="{FF2B5EF4-FFF2-40B4-BE49-F238E27FC236}">
                <a16:creationId xmlns:a16="http://schemas.microsoft.com/office/drawing/2014/main" id="{C1EEB40E-69ED-134A-8F01-0B50A3F09123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5188" y="1326723"/>
            <a:ext cx="2687337" cy="204003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B50C708-F704-CF48-9F75-3DED26D58805}"/>
              </a:ext>
            </a:extLst>
          </p:cNvPr>
          <p:cNvSpPr txBox="1"/>
          <p:nvPr/>
        </p:nvSpPr>
        <p:spPr>
          <a:xfrm>
            <a:off x="3261374" y="1253034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C9CF0BA-4748-4C49-BAB1-60DDA4A37469}"/>
              </a:ext>
            </a:extLst>
          </p:cNvPr>
          <p:cNvSpPr txBox="1"/>
          <p:nvPr/>
        </p:nvSpPr>
        <p:spPr>
          <a:xfrm>
            <a:off x="235497" y="3491927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A4A1F70-EE84-D549-BA1C-7D1CC9736CF1}"/>
              </a:ext>
            </a:extLst>
          </p:cNvPr>
          <p:cNvSpPr txBox="1"/>
          <p:nvPr/>
        </p:nvSpPr>
        <p:spPr>
          <a:xfrm>
            <a:off x="235497" y="1307669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pic>
        <p:nvPicPr>
          <p:cNvPr id="26" name="Picture 15">
            <a:extLst>
              <a:ext uri="{FF2B5EF4-FFF2-40B4-BE49-F238E27FC236}">
                <a16:creationId xmlns:a16="http://schemas.microsoft.com/office/drawing/2014/main" id="{C2A6C77F-194A-164E-97EF-4C70B0EC16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129" y="5855037"/>
            <a:ext cx="4903622" cy="2475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9FDF7E85-F0BF-AC4A-AE5A-DCF656A28F95}"/>
              </a:ext>
            </a:extLst>
          </p:cNvPr>
          <p:cNvSpPr txBox="1"/>
          <p:nvPr/>
        </p:nvSpPr>
        <p:spPr>
          <a:xfrm>
            <a:off x="410261" y="6044305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</a:t>
            </a:r>
          </a:p>
        </p:txBody>
      </p:sp>
      <p:pic>
        <p:nvPicPr>
          <p:cNvPr id="4" name="Picture 3" descr="Chart, histogram&#10;&#10;Description automatically generated">
            <a:extLst>
              <a:ext uri="{FF2B5EF4-FFF2-40B4-BE49-F238E27FC236}">
                <a16:creationId xmlns:a16="http://schemas.microsoft.com/office/drawing/2014/main" id="{38B7DC22-D582-BBFD-AA3D-605637DFDF4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474" y="3507781"/>
            <a:ext cx="2874847" cy="233091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0C19F0D-ACF3-00D7-F7B7-38244BDF643B}"/>
              </a:ext>
            </a:extLst>
          </p:cNvPr>
          <p:cNvSpPr txBox="1"/>
          <p:nvPr/>
        </p:nvSpPr>
        <p:spPr>
          <a:xfrm>
            <a:off x="3270894" y="3505705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9D483A0-F693-6BFB-414E-AF08A46A1748}"/>
              </a:ext>
            </a:extLst>
          </p:cNvPr>
          <p:cNvPicPr/>
          <p:nvPr/>
        </p:nvPicPr>
        <p:blipFill>
          <a:blip r:embed="rId6"/>
          <a:stretch/>
        </p:blipFill>
        <p:spPr>
          <a:xfrm>
            <a:off x="3591387" y="3505705"/>
            <a:ext cx="2821139" cy="2332988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229799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BDFA3CC-4766-E44B-99DC-DDCB9F2586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10" r="50120"/>
          <a:stretch/>
        </p:blipFill>
        <p:spPr>
          <a:xfrm>
            <a:off x="3740188" y="1525445"/>
            <a:ext cx="2380442" cy="1752400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4A7A1121-E771-5545-A4FC-731AE6A0FD87}"/>
              </a:ext>
            </a:extLst>
          </p:cNvPr>
          <p:cNvSpPr txBox="1">
            <a:spLocks/>
          </p:cNvSpPr>
          <p:nvPr/>
        </p:nvSpPr>
        <p:spPr>
          <a:xfrm>
            <a:off x="89480" y="70226"/>
            <a:ext cx="6679039" cy="1225352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 dirty="0"/>
              <a:t>Supplementary Figure 7. </a:t>
            </a:r>
          </a:p>
          <a:p>
            <a:pPr fontAlgn="base"/>
            <a:r>
              <a:rPr lang="en-GB" sz="1400" dirty="0"/>
              <a:t>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53FA3E-6BBF-9C4C-A061-D23A42C29DDE}"/>
              </a:ext>
            </a:extLst>
          </p:cNvPr>
          <p:cNvSpPr txBox="1"/>
          <p:nvPr/>
        </p:nvSpPr>
        <p:spPr>
          <a:xfrm>
            <a:off x="3302904" y="1482324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1AE16DC-280F-4B4F-97BD-E4217B8C9B8C}"/>
              </a:ext>
            </a:extLst>
          </p:cNvPr>
          <p:cNvSpPr txBox="1"/>
          <p:nvPr/>
        </p:nvSpPr>
        <p:spPr>
          <a:xfrm>
            <a:off x="481282" y="1482324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F1FC74-DD89-5417-1055-7CDEDCFC9D25}"/>
              </a:ext>
            </a:extLst>
          </p:cNvPr>
          <p:cNvSpPr txBox="1"/>
          <p:nvPr/>
        </p:nvSpPr>
        <p:spPr>
          <a:xfrm>
            <a:off x="3293864" y="3387251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D0C0DF17-72BC-C5DC-FA6A-C0C1F85B2616}"/>
              </a:ext>
            </a:extLst>
          </p:cNvPr>
          <p:cNvGrpSpPr/>
          <p:nvPr/>
        </p:nvGrpSpPr>
        <p:grpSpPr>
          <a:xfrm>
            <a:off x="792477" y="3379576"/>
            <a:ext cx="2304869" cy="1752400"/>
            <a:chOff x="517526" y="1374099"/>
            <a:chExt cx="3142571" cy="2271009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AA84872-2C72-52A0-5C75-1E32F9B003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0443"/>
            <a:stretch/>
          </p:blipFill>
          <p:spPr>
            <a:xfrm>
              <a:off x="547140" y="1374099"/>
              <a:ext cx="3082976" cy="2271009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AC1A0EA-1276-C8EC-3740-5EE3BF8D9100}"/>
                </a:ext>
              </a:extLst>
            </p:cNvPr>
            <p:cNvSpPr txBox="1"/>
            <p:nvPr/>
          </p:nvSpPr>
          <p:spPr>
            <a:xfrm rot="10800000" flipV="1">
              <a:off x="2965920" y="2113949"/>
              <a:ext cx="694177" cy="18953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GB" sz="6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30D2E14-D330-C6B9-671B-4B9D2FB3FD51}"/>
                </a:ext>
              </a:extLst>
            </p:cNvPr>
            <p:cNvSpPr txBox="1"/>
            <p:nvPr/>
          </p:nvSpPr>
          <p:spPr>
            <a:xfrm rot="10800000" flipV="1">
              <a:off x="517526" y="1456880"/>
              <a:ext cx="172021" cy="2220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GB" sz="600" dirty="0"/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9BB605E5-ED4B-3C12-B086-80D09447923E}"/>
              </a:ext>
            </a:extLst>
          </p:cNvPr>
          <p:cNvSpPr txBox="1"/>
          <p:nvPr/>
        </p:nvSpPr>
        <p:spPr>
          <a:xfrm>
            <a:off x="474190" y="3349143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91A775-0416-E8CE-5EA5-ACFD4668047E}"/>
              </a:ext>
            </a:extLst>
          </p:cNvPr>
          <p:cNvSpPr txBox="1"/>
          <p:nvPr/>
        </p:nvSpPr>
        <p:spPr>
          <a:xfrm>
            <a:off x="3366116" y="5203735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EED0FC5-8514-6492-A613-6F2B0F2B571E}"/>
              </a:ext>
            </a:extLst>
          </p:cNvPr>
          <p:cNvSpPr txBox="1"/>
          <p:nvPr/>
        </p:nvSpPr>
        <p:spPr>
          <a:xfrm>
            <a:off x="375948" y="5238841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89A6EA9-2A16-5B38-509F-1FD8672265DC}"/>
              </a:ext>
            </a:extLst>
          </p:cNvPr>
          <p:cNvSpPr txBox="1"/>
          <p:nvPr/>
        </p:nvSpPr>
        <p:spPr>
          <a:xfrm>
            <a:off x="3449017" y="7026620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A6485E1-F830-6A7C-CE06-3B3FDA321417}"/>
              </a:ext>
            </a:extLst>
          </p:cNvPr>
          <p:cNvSpPr txBox="1"/>
          <p:nvPr/>
        </p:nvSpPr>
        <p:spPr>
          <a:xfrm>
            <a:off x="402690" y="7026620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98C5C79C-0F4B-985F-E9AB-8A2C01F94AE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85"/>
          <a:stretch/>
        </p:blipFill>
        <p:spPr>
          <a:xfrm>
            <a:off x="740200" y="5266610"/>
            <a:ext cx="2535550" cy="172691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C325165-0FBB-CEEB-3C36-018F5F6D518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1631" y="7074408"/>
            <a:ext cx="2248889" cy="162451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BB3F902-7F82-B191-D903-1DBA90B321D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5757" y="8751289"/>
            <a:ext cx="1981589" cy="181128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EFE9C49-0E3A-0537-7703-0CEC29DDAEF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1523" y="8732511"/>
            <a:ext cx="2188998" cy="1811287"/>
          </a:xfrm>
          <a:prstGeom prst="rect">
            <a:avLst/>
          </a:prstGeom>
        </p:spPr>
      </p:pic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0FB65F08-047E-4304-92CC-FC9ACD2585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907275"/>
              </p:ext>
            </p:extLst>
          </p:nvPr>
        </p:nvGraphicFramePr>
        <p:xfrm>
          <a:off x="3782645" y="3529112"/>
          <a:ext cx="2271009" cy="1205540"/>
        </p:xfrm>
        <a:graphic>
          <a:graphicData uri="http://schemas.openxmlformats.org/drawingml/2006/table">
            <a:tbl>
              <a:tblPr/>
              <a:tblGrid>
                <a:gridCol w="757003">
                  <a:extLst>
                    <a:ext uri="{9D8B030D-6E8A-4147-A177-3AD203B41FA5}">
                      <a16:colId xmlns:a16="http://schemas.microsoft.com/office/drawing/2014/main" val="1583476273"/>
                    </a:ext>
                  </a:extLst>
                </a:gridCol>
                <a:gridCol w="757003">
                  <a:extLst>
                    <a:ext uri="{9D8B030D-6E8A-4147-A177-3AD203B41FA5}">
                      <a16:colId xmlns:a16="http://schemas.microsoft.com/office/drawing/2014/main" val="929435968"/>
                    </a:ext>
                  </a:extLst>
                </a:gridCol>
                <a:gridCol w="757003">
                  <a:extLst>
                    <a:ext uri="{9D8B030D-6E8A-4147-A177-3AD203B41FA5}">
                      <a16:colId xmlns:a16="http://schemas.microsoft.com/office/drawing/2014/main" val="2002112217"/>
                    </a:ext>
                  </a:extLst>
                </a:gridCol>
              </a:tblGrid>
              <a:tr h="301385">
                <a:tc>
                  <a:txBody>
                    <a:bodyPr/>
                    <a:lstStyle/>
                    <a:p>
                      <a:pPr algn="l" rtl="0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SS predic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5284063"/>
                  </a:ext>
                </a:extLst>
              </a:tr>
              <a:tr h="301385">
                <a:tc>
                  <a:txBody>
                    <a:bodyPr/>
                    <a:lstStyle/>
                    <a:p>
                      <a:pPr algn="l" rtl="0" fontAlgn="ctr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7908794"/>
                  </a:ext>
                </a:extLst>
              </a:tr>
              <a:tr h="30138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 (86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 (14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1812395"/>
                  </a:ext>
                </a:extLst>
              </a:tr>
              <a:tr h="30138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 (10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 (9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6656714"/>
                  </a:ext>
                </a:extLst>
              </a:tr>
            </a:tbl>
          </a:graphicData>
        </a:graphic>
      </p:graphicFrame>
      <p:graphicFrame>
        <p:nvGraphicFramePr>
          <p:cNvPr id="25" name="Table 24">
            <a:extLst>
              <a:ext uri="{FF2B5EF4-FFF2-40B4-BE49-F238E27FC236}">
                <a16:creationId xmlns:a16="http://schemas.microsoft.com/office/drawing/2014/main" id="{A7D7BEF0-AEAA-4C4F-B90E-E99329766A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4524172"/>
              </p:ext>
            </p:extLst>
          </p:nvPr>
        </p:nvGraphicFramePr>
        <p:xfrm>
          <a:off x="921707" y="7269636"/>
          <a:ext cx="2271009" cy="1205540"/>
        </p:xfrm>
        <a:graphic>
          <a:graphicData uri="http://schemas.openxmlformats.org/drawingml/2006/table">
            <a:tbl>
              <a:tblPr/>
              <a:tblGrid>
                <a:gridCol w="757003">
                  <a:extLst>
                    <a:ext uri="{9D8B030D-6E8A-4147-A177-3AD203B41FA5}">
                      <a16:colId xmlns:a16="http://schemas.microsoft.com/office/drawing/2014/main" val="1583476273"/>
                    </a:ext>
                  </a:extLst>
                </a:gridCol>
                <a:gridCol w="757003">
                  <a:extLst>
                    <a:ext uri="{9D8B030D-6E8A-4147-A177-3AD203B41FA5}">
                      <a16:colId xmlns:a16="http://schemas.microsoft.com/office/drawing/2014/main" val="929435968"/>
                    </a:ext>
                  </a:extLst>
                </a:gridCol>
                <a:gridCol w="757003">
                  <a:extLst>
                    <a:ext uri="{9D8B030D-6E8A-4147-A177-3AD203B41FA5}">
                      <a16:colId xmlns:a16="http://schemas.microsoft.com/office/drawing/2014/main" val="2002112217"/>
                    </a:ext>
                  </a:extLst>
                </a:gridCol>
              </a:tblGrid>
              <a:tr h="301385">
                <a:tc>
                  <a:txBody>
                    <a:bodyPr/>
                    <a:lstStyle/>
                    <a:p>
                      <a:pPr algn="l" rtl="0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SS predic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5284063"/>
                  </a:ext>
                </a:extLst>
              </a:tr>
              <a:tr h="301385">
                <a:tc>
                  <a:txBody>
                    <a:bodyPr/>
                    <a:lstStyle/>
                    <a:p>
                      <a:pPr algn="l" rtl="0" fontAlgn="ctr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7908794"/>
                  </a:ext>
                </a:extLst>
              </a:tr>
              <a:tr h="30138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(66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 (33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1812395"/>
                  </a:ext>
                </a:extLst>
              </a:tr>
              <a:tr h="30138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C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(38%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 (62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6656714"/>
                  </a:ext>
                </a:extLst>
              </a:tr>
            </a:tbl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3494B56E-DC0B-482A-9BFC-BBE697DBD42F}"/>
              </a:ext>
            </a:extLst>
          </p:cNvPr>
          <p:cNvSpPr txBox="1"/>
          <p:nvPr/>
        </p:nvSpPr>
        <p:spPr>
          <a:xfrm>
            <a:off x="587051" y="8751290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i</a:t>
            </a:r>
            <a:endParaRPr lang="en-GB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44B9662-8248-4E17-AFAF-4B4D4D4376B7}"/>
              </a:ext>
            </a:extLst>
          </p:cNvPr>
          <p:cNvSpPr txBox="1"/>
          <p:nvPr/>
        </p:nvSpPr>
        <p:spPr>
          <a:xfrm>
            <a:off x="3604295" y="8732511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j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6D179B1-56E7-4FB6-B9BC-70E9EA3E9B8A}"/>
              </a:ext>
            </a:extLst>
          </p:cNvPr>
          <p:cNvGrpSpPr/>
          <p:nvPr/>
        </p:nvGrpSpPr>
        <p:grpSpPr>
          <a:xfrm>
            <a:off x="4033778" y="5238841"/>
            <a:ext cx="2146743" cy="1769088"/>
            <a:chOff x="4033778" y="5238841"/>
            <a:chExt cx="2146743" cy="1769088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AEF1E039-3579-14ED-9B50-53BA2A111A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85"/>
            <a:stretch/>
          </p:blipFill>
          <p:spPr>
            <a:xfrm>
              <a:off x="4033778" y="5238841"/>
              <a:ext cx="2146743" cy="1673807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AEA11C2-F5CA-4CD1-BDFD-EEEA59D93507}"/>
                </a:ext>
              </a:extLst>
            </p:cNvPr>
            <p:cNvSpPr txBox="1"/>
            <p:nvPr/>
          </p:nvSpPr>
          <p:spPr>
            <a:xfrm>
              <a:off x="4593773" y="6838652"/>
              <a:ext cx="75111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500" dirty="0"/>
                <a:t>Sample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023B6AA-CF6C-40E0-9E51-90098A836BD3}"/>
                </a:ext>
              </a:extLst>
            </p:cNvPr>
            <p:cNvSpPr txBox="1"/>
            <p:nvPr/>
          </p:nvSpPr>
          <p:spPr>
            <a:xfrm>
              <a:off x="5680540" y="5790303"/>
              <a:ext cx="499980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endParaRPr lang="en-GB" sz="500" dirty="0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25727D0-2212-4D2F-8D29-CFD766743EEA}"/>
              </a:ext>
            </a:extLst>
          </p:cNvPr>
          <p:cNvGrpSpPr/>
          <p:nvPr/>
        </p:nvGrpSpPr>
        <p:grpSpPr>
          <a:xfrm>
            <a:off x="792477" y="1563036"/>
            <a:ext cx="2501387" cy="1677218"/>
            <a:chOff x="792477" y="1563036"/>
            <a:chExt cx="2501387" cy="1677218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98B19A47-0B49-492C-F375-FDF41090E53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477" y="1563036"/>
              <a:ext cx="2063364" cy="1677218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48EF98B-E0E9-458D-A1B7-90636018A219}"/>
                </a:ext>
              </a:extLst>
            </p:cNvPr>
            <p:cNvSpPr txBox="1"/>
            <p:nvPr/>
          </p:nvSpPr>
          <p:spPr>
            <a:xfrm rot="10800000" flipV="1">
              <a:off x="2757576" y="2241666"/>
              <a:ext cx="53628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dirty="0"/>
                <a:t>GSE87211</a:t>
              </a:r>
            </a:p>
            <a:p>
              <a:r>
                <a:rPr lang="en-GB" sz="600" dirty="0"/>
                <a:t>Discovery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CE222B9-AE76-45F5-84C1-5C48F51FFFD5}"/>
                </a:ext>
              </a:extLst>
            </p:cNvPr>
            <p:cNvSpPr txBox="1"/>
            <p:nvPr/>
          </p:nvSpPr>
          <p:spPr>
            <a:xfrm rot="10800000" flipV="1">
              <a:off x="2655247" y="2157651"/>
              <a:ext cx="509133" cy="146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GB" sz="6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338519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05C8652-FDB9-884E-9842-EB1684B231C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049" y="1185704"/>
            <a:ext cx="6589371" cy="4118357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4A7A1121-E771-5545-A4FC-731AE6A0FD87}"/>
              </a:ext>
            </a:extLst>
          </p:cNvPr>
          <p:cNvSpPr txBox="1">
            <a:spLocks/>
          </p:cNvSpPr>
          <p:nvPr/>
        </p:nvSpPr>
        <p:spPr>
          <a:xfrm>
            <a:off x="178961" y="125836"/>
            <a:ext cx="6679039" cy="969434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 dirty="0"/>
              <a:t>Supplementary Figure 8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F4493AB-C5DB-3142-9342-0E41D528B7C5}"/>
              </a:ext>
            </a:extLst>
          </p:cNvPr>
          <p:cNvSpPr txBox="1"/>
          <p:nvPr/>
        </p:nvSpPr>
        <p:spPr>
          <a:xfrm>
            <a:off x="60288" y="1146876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53FA3E-6BBF-9C4C-A061-D23A42C29DDE}"/>
              </a:ext>
            </a:extLst>
          </p:cNvPr>
          <p:cNvSpPr txBox="1"/>
          <p:nvPr/>
        </p:nvSpPr>
        <p:spPr>
          <a:xfrm>
            <a:off x="2245208" y="1159424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DEEBD61-029E-8A41-A0A3-0C98CE292AD8}"/>
              </a:ext>
            </a:extLst>
          </p:cNvPr>
          <p:cNvSpPr txBox="1"/>
          <p:nvPr/>
        </p:nvSpPr>
        <p:spPr>
          <a:xfrm>
            <a:off x="4427375" y="1171147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4C72BBA-51AC-4546-8073-CD3906E0C5B5}"/>
              </a:ext>
            </a:extLst>
          </p:cNvPr>
          <p:cNvSpPr txBox="1"/>
          <p:nvPr/>
        </p:nvSpPr>
        <p:spPr>
          <a:xfrm>
            <a:off x="4427375" y="3261204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D65BEC3-8BFE-5C4E-9D35-29C20F6FD0FD}"/>
              </a:ext>
            </a:extLst>
          </p:cNvPr>
          <p:cNvSpPr txBox="1"/>
          <p:nvPr/>
        </p:nvSpPr>
        <p:spPr>
          <a:xfrm>
            <a:off x="2198316" y="3222686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BDC610-7A4F-3442-BAB5-D459E6E52742}"/>
              </a:ext>
            </a:extLst>
          </p:cNvPr>
          <p:cNvSpPr txBox="1"/>
          <p:nvPr/>
        </p:nvSpPr>
        <p:spPr>
          <a:xfrm>
            <a:off x="20096" y="3234409"/>
            <a:ext cx="41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930757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FD7D93E-359B-EB44-8EE3-A0C865B1187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2626" y="6721586"/>
            <a:ext cx="2266651" cy="269839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3A4C54A-B736-DB40-9E64-CD5F26A571E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9721" y="6728971"/>
            <a:ext cx="2266651" cy="269839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29037CB-CA57-E34D-997F-203E1481F5D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45" y="6727972"/>
            <a:ext cx="2266651" cy="269839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2720ABA-B2A2-6B48-908A-E1DCE97DB53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3541" y="3925046"/>
            <a:ext cx="2266651" cy="269839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72E15EE-EA6C-4D4A-BBDE-099FF72F4D9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1881" y="3915654"/>
            <a:ext cx="2266651" cy="269839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F760EAD-B60F-004A-9E59-3B1205DB349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56" y="3906263"/>
            <a:ext cx="2266651" cy="2698393"/>
          </a:xfrm>
          <a:prstGeom prst="rect">
            <a:avLst/>
          </a:prstGeom>
        </p:spPr>
      </p:pic>
      <p:sp>
        <p:nvSpPr>
          <p:cNvPr id="20" name="Title 1">
            <a:extLst>
              <a:ext uri="{FF2B5EF4-FFF2-40B4-BE49-F238E27FC236}">
                <a16:creationId xmlns:a16="http://schemas.microsoft.com/office/drawing/2014/main" id="{F20CDE1B-5073-554E-9E09-A26972730B98}"/>
              </a:ext>
            </a:extLst>
          </p:cNvPr>
          <p:cNvSpPr txBox="1">
            <a:spLocks/>
          </p:cNvSpPr>
          <p:nvPr/>
        </p:nvSpPr>
        <p:spPr>
          <a:xfrm>
            <a:off x="178961" y="125836"/>
            <a:ext cx="6679039" cy="746619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base"/>
            <a:r>
              <a:rPr lang="en-GB" sz="1400" dirty="0"/>
              <a:t>Supplementary Figure 9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E44AA2E-C7F3-FF44-9CC1-00B0F848CEA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880" y="1131850"/>
            <a:ext cx="2256902" cy="268678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90A7647-11F1-4341-8310-FD0B854751AD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6746" y="1140084"/>
            <a:ext cx="2256902" cy="268678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38C3768-817A-9745-9A78-0EAC048C970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0" y="1141228"/>
            <a:ext cx="2256902" cy="2686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5603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3F46D077191524789927868CF947692" ma:contentTypeVersion="17" ma:contentTypeDescription="Create a new document." ma:contentTypeScope="" ma:versionID="b98a40ecaa714fe6f795b325ac34485c">
  <xsd:schema xmlns:xsd="http://www.w3.org/2001/XMLSchema" xmlns:xs="http://www.w3.org/2001/XMLSchema" xmlns:p="http://schemas.microsoft.com/office/2006/metadata/properties" xmlns:ns3="adcfa805-e237-4af0-86e0-efffb5656f00" xmlns:ns4="2bb55023-286f-46d7-8b8e-5a79189d33e9" targetNamespace="http://schemas.microsoft.com/office/2006/metadata/properties" ma:root="true" ma:fieldsID="b2ae3f7e3ebf3f248584f545818f1efa" ns3:_="" ns4:_="">
    <xsd:import namespace="adcfa805-e237-4af0-86e0-efffb5656f00"/>
    <xsd:import namespace="2bb55023-286f-46d7-8b8e-5a79189d33e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dcfa805-e237-4af0-86e0-efffb5656f0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2" nillable="true" ma:displayName="Length (seconds)" ma:internalName="MediaLengthInSeconds" ma:readOnly="true">
      <xsd:simpleType>
        <xsd:restriction base="dms:Unknown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bb55023-286f-46d7-8b8e-5a79189d33e9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1709DFE-E253-4B08-BCEA-098B0033900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cfa805-e237-4af0-86e0-efffb5656f00"/>
    <ds:schemaRef ds:uri="2bb55023-286f-46d7-8b8e-5a79189d33e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6871907-E1E5-458C-8162-D746EBD2678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D52CEFF-F642-4DBF-B987-D8BFFC83F259}">
  <ds:schemaRefs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purl.org/dc/terms/"/>
    <ds:schemaRef ds:uri="2bb55023-286f-46d7-8b8e-5a79189d33e9"/>
    <ds:schemaRef ds:uri="adcfa805-e237-4af0-86e0-efffb5656f00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45</TotalTime>
  <Words>133</Words>
  <Application>Microsoft Office PowerPoint</Application>
  <PresentationFormat>Custom</PresentationFormat>
  <Paragraphs>71</Paragraphs>
  <Slides>1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Supplementary Figure 1. </vt:lpstr>
      <vt:lpstr>PowerPoint Presentation</vt:lpstr>
      <vt:lpstr>PowerPoint Presentation</vt:lpstr>
      <vt:lpstr>Supplementary Figure 4.   </vt:lpstr>
      <vt:lpstr>Supplementary Figure 5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dhir Malla</dc:creator>
  <cp:lastModifiedBy>Timothy Maughan</cp:lastModifiedBy>
  <cp:revision>477</cp:revision>
  <dcterms:created xsi:type="dcterms:W3CDTF">2019-07-24T13:57:52Z</dcterms:created>
  <dcterms:modified xsi:type="dcterms:W3CDTF">2024-07-03T18:33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3F46D077191524789927868CF947692</vt:lpwstr>
  </property>
</Properties>
</file>